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Default Extension="wdp" ContentType="image/vnd.ms-photo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0"/>
  </p:notesMasterIdLst>
  <p:sldIdLst>
    <p:sldId id="305" r:id="rId2"/>
    <p:sldId id="335" r:id="rId3"/>
    <p:sldId id="329" r:id="rId4"/>
    <p:sldId id="325" r:id="rId5"/>
    <p:sldId id="334" r:id="rId6"/>
    <p:sldId id="336" r:id="rId7"/>
    <p:sldId id="327" r:id="rId8"/>
    <p:sldId id="330" r:id="rId9"/>
  </p:sldIdLst>
  <p:sldSz cx="6858000" cy="9144000" type="screen4x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0000FF"/>
    <a:srgbClr val="CC3300"/>
    <a:srgbClr val="800080"/>
    <a:srgbClr val="008000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1669" autoAdjust="0"/>
    <p:restoredTop sz="94660"/>
  </p:normalViewPr>
  <p:slideViewPr>
    <p:cSldViewPr snapToGrid="0">
      <p:cViewPr>
        <p:scale>
          <a:sx n="125" d="100"/>
          <a:sy n="125" d="100"/>
        </p:scale>
        <p:origin x="-134" y="557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8AA7510-C990-4B13-A8FC-F849D97FE652}" type="datetimeFigureOut">
              <a:rPr lang="zh-CN" altLang="en-US" smtClean="0"/>
              <a:pPr/>
              <a:t>2017/5/2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5F5D351-B880-4ADB-8A81-001B7A9BAC3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88155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5F5D351-B880-4ADB-8A81-001B7A9BAC39}" type="slidenum">
              <a:rPr lang="zh-CN" altLang="en-US" smtClean="0"/>
              <a:pPr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6601895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D3D82-B2BB-4D7B-AF02-C60E9DDDD5F5}" type="datetimeFigureOut">
              <a:rPr lang="zh-CN" altLang="en-US" smtClean="0"/>
              <a:pPr/>
              <a:t>2017/5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DE5FD-1A4E-4F24-A226-6132AE8058D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4425236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D3D82-B2BB-4D7B-AF02-C60E9DDDD5F5}" type="datetimeFigureOut">
              <a:rPr lang="zh-CN" altLang="en-US" smtClean="0"/>
              <a:pPr/>
              <a:t>2017/5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DE5FD-1A4E-4F24-A226-6132AE8058D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41681447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D3D82-B2BB-4D7B-AF02-C60E9DDDD5F5}" type="datetimeFigureOut">
              <a:rPr lang="zh-CN" altLang="en-US" smtClean="0"/>
              <a:pPr/>
              <a:t>2017/5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DE5FD-1A4E-4F24-A226-6132AE8058D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978410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D3D82-B2BB-4D7B-AF02-C60E9DDDD5F5}" type="datetimeFigureOut">
              <a:rPr lang="zh-CN" altLang="en-US" smtClean="0"/>
              <a:pPr/>
              <a:t>2017/5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DE5FD-1A4E-4F24-A226-6132AE8058D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6358227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D3D82-B2BB-4D7B-AF02-C60E9DDDD5F5}" type="datetimeFigureOut">
              <a:rPr lang="zh-CN" altLang="en-US" smtClean="0"/>
              <a:pPr/>
              <a:t>2017/5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DE5FD-1A4E-4F24-A226-6132AE8058D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5326177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D3D82-B2BB-4D7B-AF02-C60E9DDDD5F5}" type="datetimeFigureOut">
              <a:rPr lang="zh-CN" altLang="en-US" smtClean="0"/>
              <a:pPr/>
              <a:t>2017/5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DE5FD-1A4E-4F24-A226-6132AE8058D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5585438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D3D82-B2BB-4D7B-AF02-C60E9DDDD5F5}" type="datetimeFigureOut">
              <a:rPr lang="zh-CN" altLang="en-US" smtClean="0"/>
              <a:pPr/>
              <a:t>2017/5/2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DE5FD-1A4E-4F24-A226-6132AE8058D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0198094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D3D82-B2BB-4D7B-AF02-C60E9DDDD5F5}" type="datetimeFigureOut">
              <a:rPr lang="zh-CN" altLang="en-US" smtClean="0"/>
              <a:pPr/>
              <a:t>2017/5/2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DE5FD-1A4E-4F24-A226-6132AE8058D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9718511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D3D82-B2BB-4D7B-AF02-C60E9DDDD5F5}" type="datetimeFigureOut">
              <a:rPr lang="zh-CN" altLang="en-US" smtClean="0"/>
              <a:pPr/>
              <a:t>2017/5/2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DE5FD-1A4E-4F24-A226-6132AE8058D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1414067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D3D82-B2BB-4D7B-AF02-C60E9DDDD5F5}" type="datetimeFigureOut">
              <a:rPr lang="zh-CN" altLang="en-US" smtClean="0"/>
              <a:pPr/>
              <a:t>2017/5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DE5FD-1A4E-4F24-A226-6132AE8058D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9828140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D3D82-B2BB-4D7B-AF02-C60E9DDDD5F5}" type="datetimeFigureOut">
              <a:rPr lang="zh-CN" altLang="en-US" smtClean="0"/>
              <a:pPr/>
              <a:t>2017/5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DE5FD-1A4E-4F24-A226-6132AE8058D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6288284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5D3D82-B2BB-4D7B-AF02-C60E9DDDD5F5}" type="datetimeFigureOut">
              <a:rPr lang="zh-CN" altLang="en-US" smtClean="0"/>
              <a:pPr/>
              <a:t>2017/5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6DE5FD-1A4E-4F24-A226-6132AE8058D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5597951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hyperlink" Target="http://www.cbs.dtu.dk/services/TMHMM/" TargetMode="External"/><Relationship Id="rId2" Type="http://schemas.openxmlformats.org/officeDocument/2006/relationships/hyperlink" Target="http://www.ch.embnet.org/software/TMPRED_form.html" TargetMode="Externa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7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em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12.png"/><Relationship Id="rId7" Type="http://schemas.openxmlformats.org/officeDocument/2006/relationships/image" Target="../media/image1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image" Target="../media/image16.emf"/><Relationship Id="rId5" Type="http://schemas.openxmlformats.org/officeDocument/2006/relationships/image" Target="../media/image13.pn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15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TextBox 30"/>
          <p:cNvSpPr txBox="1"/>
          <p:nvPr/>
        </p:nvSpPr>
        <p:spPr>
          <a:xfrm>
            <a:off x="484234" y="105870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488949" y="8209683"/>
            <a:ext cx="13875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-1.</a:t>
            </a: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7525" y="6680842"/>
            <a:ext cx="5768976" cy="1501466"/>
          </a:xfrm>
          <a:prstGeom prst="rect">
            <a:avLst/>
          </a:prstGeom>
        </p:spPr>
      </p:pic>
      <p:sp>
        <p:nvSpPr>
          <p:cNvPr id="23" name="TextBox 30"/>
          <p:cNvSpPr txBox="1"/>
          <p:nvPr/>
        </p:nvSpPr>
        <p:spPr>
          <a:xfrm>
            <a:off x="481059" y="443372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28441" y="3463110"/>
            <a:ext cx="3297483" cy="3096271"/>
          </a:xfrm>
          <a:prstGeom prst="rect">
            <a:avLst/>
          </a:prstGeom>
        </p:spPr>
      </p:pic>
      <p:sp>
        <p:nvSpPr>
          <p:cNvPr id="30" name="TextBox 30"/>
          <p:cNvSpPr txBox="1"/>
          <p:nvPr/>
        </p:nvSpPr>
        <p:spPr>
          <a:xfrm>
            <a:off x="481059" y="645302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oup 2"/>
          <p:cNvGrpSpPr>
            <a:grpSpLocks/>
          </p:cNvGrpSpPr>
          <p:nvPr/>
        </p:nvGrpSpPr>
        <p:grpSpPr bwMode="auto">
          <a:xfrm>
            <a:off x="552450" y="1398972"/>
            <a:ext cx="5111750" cy="2055428"/>
            <a:chOff x="2418" y="8282"/>
            <a:chExt cx="7377" cy="2607"/>
          </a:xfrm>
        </p:grpSpPr>
        <p:grpSp>
          <p:nvGrpSpPr>
            <p:cNvPr id="6" name="Group 3"/>
            <p:cNvGrpSpPr>
              <a:grpSpLocks/>
            </p:cNvGrpSpPr>
            <p:nvPr/>
          </p:nvGrpSpPr>
          <p:grpSpPr bwMode="auto">
            <a:xfrm>
              <a:off x="2418" y="8282"/>
              <a:ext cx="7377" cy="2607"/>
              <a:chOff x="2340" y="5664"/>
              <a:chExt cx="8274" cy="2615"/>
            </a:xfrm>
          </p:grpSpPr>
          <p:pic>
            <p:nvPicPr>
              <p:cNvPr id="39" name="Picture 43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340" y="5664"/>
                <a:ext cx="8274" cy="2615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8" name="矩形 1"/>
              <p:cNvSpPr>
                <a:spLocks noChangeArrowheads="1"/>
              </p:cNvSpPr>
              <p:nvPr/>
            </p:nvSpPr>
            <p:spPr bwMode="auto">
              <a:xfrm>
                <a:off x="6029" y="6771"/>
                <a:ext cx="3871" cy="135"/>
              </a:xfrm>
              <a:prstGeom prst="rect">
                <a:avLst/>
              </a:prstGeom>
              <a:noFill/>
              <a:ln w="19050">
                <a:solidFill>
                  <a:srgbClr val="F80C44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" name="矩形 58"/>
              <p:cNvSpPr>
                <a:spLocks noChangeArrowheads="1"/>
              </p:cNvSpPr>
              <p:nvPr/>
            </p:nvSpPr>
            <p:spPr bwMode="auto">
              <a:xfrm>
                <a:off x="3104" y="7154"/>
                <a:ext cx="5867" cy="135"/>
              </a:xfrm>
              <a:prstGeom prst="rect">
                <a:avLst/>
              </a:prstGeom>
              <a:noFill/>
              <a:ln w="19050">
                <a:solidFill>
                  <a:srgbClr val="F80C44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7" name="Rectangle 7"/>
            <p:cNvSpPr>
              <a:spLocks noChangeArrowheads="1"/>
            </p:cNvSpPr>
            <p:nvPr/>
          </p:nvSpPr>
          <p:spPr bwMode="auto">
            <a:xfrm>
              <a:off x="3528" y="8638"/>
              <a:ext cx="787" cy="228"/>
            </a:xfrm>
            <a:prstGeom prst="rect">
              <a:avLst/>
            </a:prstGeom>
            <a:noFill/>
            <a:ln w="15875">
              <a:solidFill>
                <a:srgbClr val="FF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</p:grpSp>
      <p:sp>
        <p:nvSpPr>
          <p:cNvPr id="15" name="文本框 14"/>
          <p:cNvSpPr txBox="1"/>
          <p:nvPr/>
        </p:nvSpPr>
        <p:spPr>
          <a:xfrm>
            <a:off x="403224" y="560792"/>
            <a:ext cx="55118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Information (Total 6 Figures and 2 Tables)</a:t>
            </a:r>
            <a:endParaRPr lang="en-US" altLang="zh-CN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8682322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TextBox 30"/>
          <p:cNvSpPr txBox="1"/>
          <p:nvPr/>
        </p:nvSpPr>
        <p:spPr>
          <a:xfrm>
            <a:off x="836659" y="136985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581025" y="5437908"/>
            <a:ext cx="5762624" cy="2062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Bef>
                <a:spcPts val="600"/>
              </a:spcBef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. Bioinformatic prediction of HtNHX1 and HtNHX2 structures.</a:t>
            </a:r>
          </a:p>
          <a:p>
            <a:pPr algn="just">
              <a:spcBef>
                <a:spcPts val="600"/>
              </a:spcBef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: Analysis Alignment of deduced amino acids sequences of HtNHX1 and HtNHX2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;</a:t>
            </a:r>
          </a:p>
          <a:p>
            <a:pPr algn="just">
              <a:spcBef>
                <a:spcPts val="600"/>
              </a:spcBef>
            </a:pP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: phylogenic tree of some known and putative plant K</a:t>
            </a:r>
            <a:r>
              <a:rPr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(Na</a:t>
            </a:r>
            <a:r>
              <a:rPr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/H</a:t>
            </a:r>
            <a:r>
              <a:rPr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tiporters;</a:t>
            </a:r>
          </a:p>
          <a:p>
            <a:pPr algn="just">
              <a:spcBef>
                <a:spcPts val="600"/>
              </a:spcBef>
            </a:pP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: conserved 8 amino acids region showing the difference between plant type-I and type-II members of NHX family; </a:t>
            </a:r>
            <a:endParaRPr lang="en-US" altLang="zh-CN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spcBef>
                <a:spcPts val="600"/>
              </a:spcBef>
            </a:pP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, E and F: predicted transmembrane topology model of HtNHX1 (D) by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TMpred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hlinkClick r:id="rId2"/>
              </a:rPr>
              <a:t>http://www.ch.embnet.org/software/TMPRED_form.html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 or by TMHMM2.0 (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hlinkClick r:id="rId3"/>
              </a:rPr>
              <a:t>http://www.cbs.dtu.dk/services/TMHMM/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 and the model-1 of HtNHX2 by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TMpred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(E) or model-2 by TMHMM2.0 (F).</a:t>
            </a:r>
          </a:p>
        </p:txBody>
      </p:sp>
      <p:pic>
        <p:nvPicPr>
          <p:cNvPr id="13" name="图片 1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01963" y="1132185"/>
            <a:ext cx="3891270" cy="3760490"/>
          </a:xfrm>
          <a:prstGeom prst="rect">
            <a:avLst/>
          </a:prstGeom>
        </p:spPr>
      </p:pic>
      <p:sp>
        <p:nvSpPr>
          <p:cNvPr id="21" name="TextBox 30"/>
          <p:cNvSpPr txBox="1"/>
          <p:nvPr/>
        </p:nvSpPr>
        <p:spPr>
          <a:xfrm>
            <a:off x="839834" y="280812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30"/>
          <p:cNvSpPr txBox="1"/>
          <p:nvPr/>
        </p:nvSpPr>
        <p:spPr>
          <a:xfrm>
            <a:off x="839834" y="4043202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4967833" y="1130767"/>
            <a:ext cx="121706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Predicted transmembrane  topology model of HtNHX1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4967832" y="2573633"/>
            <a:ext cx="121706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Predicted transmembrane  topology model-1 of HtNHX2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4971007" y="3821408"/>
            <a:ext cx="121706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Predicted transmembrane  topology model-2 of HtNHX2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4991033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TextBox 30"/>
          <p:cNvSpPr txBox="1"/>
          <p:nvPr/>
        </p:nvSpPr>
        <p:spPr>
          <a:xfrm>
            <a:off x="782684" y="59043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469899" y="7563620"/>
            <a:ext cx="582612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2. Isolation of single copy inserted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ice lines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altLang="zh-CN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HtNHX1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or </a:t>
            </a:r>
            <a:r>
              <a:rPr lang="en-US" altLang="zh-CN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HtNHX2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expression.</a:t>
            </a:r>
          </a:p>
          <a:p>
            <a:pPr algn="just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outhern Blot analysis (A) and identification of the inserted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ocalization (B), and expression abundance of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HtNHX1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HtNHX2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to </a:t>
            </a:r>
            <a:r>
              <a:rPr lang="en-US" altLang="zh-CN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Actin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C) in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he rice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enome,.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: Probe; M:Maker; The genomic DNA of WT 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（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ild type),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HtNHX1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HtNHX2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expression lines were all digested with Bam</a:t>
            </a:r>
            <a:r>
              <a:rPr lang="zh-CN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Ⅰ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nd Hind</a:t>
            </a:r>
            <a:r>
              <a:rPr lang="zh-CN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Ⅲ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13" name="TextBox 31"/>
          <p:cNvSpPr txBox="1"/>
          <p:nvPr/>
        </p:nvSpPr>
        <p:spPr>
          <a:xfrm>
            <a:off x="800100" y="2562226"/>
            <a:ext cx="305262" cy="3171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8735" y="898216"/>
            <a:ext cx="5100530" cy="1446571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3"/>
          <a:srcRect l="7591" r="1410"/>
          <a:stretch/>
        </p:blipFill>
        <p:spPr>
          <a:xfrm>
            <a:off x="741100" y="2726942"/>
            <a:ext cx="3345125" cy="4654933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74376" y="2831717"/>
            <a:ext cx="1783524" cy="4578733"/>
          </a:xfrm>
          <a:prstGeom prst="rect">
            <a:avLst/>
          </a:prstGeom>
        </p:spPr>
      </p:pic>
      <p:sp>
        <p:nvSpPr>
          <p:cNvPr id="9" name="TextBox 31"/>
          <p:cNvSpPr txBox="1"/>
          <p:nvPr/>
        </p:nvSpPr>
        <p:spPr>
          <a:xfrm>
            <a:off x="4295775" y="2562226"/>
            <a:ext cx="305262" cy="3171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8344453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/>
          <a:srcRect l="2446" t="3902" r="1423" b="24630"/>
          <a:stretch/>
        </p:blipFill>
        <p:spPr>
          <a:xfrm>
            <a:off x="2089151" y="2692852"/>
            <a:ext cx="2832346" cy="1817923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417452" y="7075700"/>
            <a:ext cx="6111996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3. Effects of overexpression of </a:t>
            </a:r>
            <a:r>
              <a:rPr lang="en-US" altLang="zh-CN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HtNHX1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zh-CN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HtNHX2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on grain yield, harvest index, and NPK concentrations in the rice grown in low K supplied soil.</a:t>
            </a:r>
          </a:p>
          <a:p>
            <a:pPr algn="just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, B: The rice was grown in K supplied soil with 0.15g-K/kg (+K) or without K fertilization (-K). Soil properties were described in Table S2. C: Concentrations of total N, P and K in the harvested straws from no K fertilizer (-K) treatment.</a:t>
            </a:r>
          </a:p>
          <a:p>
            <a:pPr algn="just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T: cv. </a:t>
            </a:r>
            <a:r>
              <a:rPr lang="en-US" altLang="zh-CN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Nipponbare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of rice; X1-1, 1-2: two T2 individual transgenic lines of expressing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HtNHX1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; X2-1, 2-2: two T2 individual transgenic lines of expressing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HtNHX2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. Different letter(s) on the column indicates the significant difference at probability at 5%. ns: no significant difference.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31"/>
          <p:cNvSpPr txBox="1"/>
          <p:nvPr/>
        </p:nvSpPr>
        <p:spPr>
          <a:xfrm>
            <a:off x="1685965" y="330518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31"/>
          <p:cNvSpPr txBox="1"/>
          <p:nvPr/>
        </p:nvSpPr>
        <p:spPr>
          <a:xfrm>
            <a:off x="1681200" y="536640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 rotWithShape="1">
          <a:blip r:embed="rId3"/>
          <a:srcRect l="1627" t="3803" r="810" b="26034"/>
          <a:stretch/>
        </p:blipFill>
        <p:spPr>
          <a:xfrm>
            <a:off x="2061210" y="4774627"/>
            <a:ext cx="2846165" cy="1767143"/>
          </a:xfrm>
          <a:prstGeom prst="rect">
            <a:avLst/>
          </a:prstGeom>
        </p:spPr>
      </p:pic>
      <p:grpSp>
        <p:nvGrpSpPr>
          <p:cNvPr id="43" name="组合 42"/>
          <p:cNvGrpSpPr/>
          <p:nvPr/>
        </p:nvGrpSpPr>
        <p:grpSpPr>
          <a:xfrm>
            <a:off x="1685971" y="524714"/>
            <a:ext cx="3200354" cy="1995007"/>
            <a:chOff x="1685971" y="524714"/>
            <a:chExt cx="3200354" cy="1995007"/>
          </a:xfrm>
        </p:grpSpPr>
        <p:pic>
          <p:nvPicPr>
            <p:cNvPr id="3" name="图片 2"/>
            <p:cNvPicPr>
              <a:picLocks noChangeAspect="1"/>
            </p:cNvPicPr>
            <p:nvPr/>
          </p:nvPicPr>
          <p:blipFill rotWithShape="1">
            <a:blip r:embed="rId4"/>
            <a:srcRect l="2104" t="4494" r="1508" b="25322"/>
            <a:stretch/>
          </p:blipFill>
          <p:spPr>
            <a:xfrm>
              <a:off x="2060575" y="743320"/>
              <a:ext cx="2825750" cy="1776401"/>
            </a:xfrm>
            <a:prstGeom prst="rect">
              <a:avLst/>
            </a:prstGeom>
          </p:spPr>
        </p:pic>
        <p:sp>
          <p:nvSpPr>
            <p:cNvPr id="7" name="TextBox 31"/>
            <p:cNvSpPr txBox="1"/>
            <p:nvPr/>
          </p:nvSpPr>
          <p:spPr>
            <a:xfrm>
              <a:off x="1685971" y="1369690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" name="组合 11"/>
            <p:cNvGrpSpPr/>
            <p:nvPr/>
          </p:nvGrpSpPr>
          <p:grpSpPr>
            <a:xfrm>
              <a:off x="2407920" y="524714"/>
              <a:ext cx="1209456" cy="431087"/>
              <a:chOff x="536236" y="983690"/>
              <a:chExt cx="1209456" cy="431087"/>
            </a:xfrm>
          </p:grpSpPr>
          <p:sp>
            <p:nvSpPr>
              <p:cNvPr id="13" name="文本框 12"/>
              <p:cNvSpPr txBox="1"/>
              <p:nvPr/>
            </p:nvSpPr>
            <p:spPr>
              <a:xfrm flipH="1">
                <a:off x="536236" y="983690"/>
                <a:ext cx="12094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4" name="组合 13"/>
              <p:cNvGrpSpPr/>
              <p:nvPr/>
            </p:nvGrpSpPr>
            <p:grpSpPr>
              <a:xfrm>
                <a:off x="600484" y="1233556"/>
                <a:ext cx="1080000" cy="181221"/>
                <a:chOff x="600484" y="1285947"/>
                <a:chExt cx="1080000" cy="181221"/>
              </a:xfrm>
            </p:grpSpPr>
            <p:cxnSp>
              <p:nvCxnSpPr>
                <p:cNvPr id="15" name="直接连接符 14"/>
                <p:cNvCxnSpPr>
                  <a:cxnSpLocks/>
                </p:cNvCxnSpPr>
                <p:nvPr/>
              </p:nvCxnSpPr>
              <p:spPr>
                <a:xfrm>
                  <a:off x="600484" y="1289496"/>
                  <a:ext cx="1080000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直接连接符 15"/>
                <p:cNvCxnSpPr>
                  <a:cxnSpLocks/>
                </p:cNvCxnSpPr>
                <p:nvPr/>
              </p:nvCxnSpPr>
              <p:spPr>
                <a:xfrm flipH="1">
                  <a:off x="607174" y="1285947"/>
                  <a:ext cx="0" cy="180000"/>
                </a:xfrm>
                <a:prstGeom prst="line">
                  <a:avLst/>
                </a:prstGeom>
                <a:ln w="285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" name="直接连接符 16"/>
                <p:cNvCxnSpPr>
                  <a:cxnSpLocks/>
                </p:cNvCxnSpPr>
                <p:nvPr/>
              </p:nvCxnSpPr>
              <p:spPr>
                <a:xfrm flipH="1">
                  <a:off x="1669834" y="1287168"/>
                  <a:ext cx="0" cy="180000"/>
                </a:xfrm>
                <a:prstGeom prst="line">
                  <a:avLst/>
                </a:prstGeom>
                <a:ln w="285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8" name="组合 17"/>
            <p:cNvGrpSpPr/>
            <p:nvPr/>
          </p:nvGrpSpPr>
          <p:grpSpPr>
            <a:xfrm>
              <a:off x="4332621" y="1143482"/>
              <a:ext cx="473475" cy="359087"/>
              <a:chOff x="1272217" y="983690"/>
              <a:chExt cx="473475" cy="359087"/>
            </a:xfrm>
          </p:grpSpPr>
          <p:sp>
            <p:nvSpPr>
              <p:cNvPr id="19" name="文本框 18"/>
              <p:cNvSpPr txBox="1"/>
              <p:nvPr/>
            </p:nvSpPr>
            <p:spPr>
              <a:xfrm flipH="1">
                <a:off x="1272217" y="983690"/>
                <a:ext cx="47347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0" name="组合 19"/>
              <p:cNvGrpSpPr/>
              <p:nvPr/>
            </p:nvGrpSpPr>
            <p:grpSpPr>
              <a:xfrm>
                <a:off x="1316764" y="1233556"/>
                <a:ext cx="396000" cy="109221"/>
                <a:chOff x="1316764" y="1285947"/>
                <a:chExt cx="396000" cy="109221"/>
              </a:xfrm>
            </p:grpSpPr>
            <p:cxnSp>
              <p:nvCxnSpPr>
                <p:cNvPr id="21" name="直接连接符 20"/>
                <p:cNvCxnSpPr>
                  <a:cxnSpLocks/>
                </p:cNvCxnSpPr>
                <p:nvPr/>
              </p:nvCxnSpPr>
              <p:spPr>
                <a:xfrm>
                  <a:off x="1316764" y="1289496"/>
                  <a:ext cx="396000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" name="直接连接符 21"/>
                <p:cNvCxnSpPr>
                  <a:cxnSpLocks/>
                </p:cNvCxnSpPr>
                <p:nvPr/>
              </p:nvCxnSpPr>
              <p:spPr>
                <a:xfrm flipH="1">
                  <a:off x="1331074" y="1285947"/>
                  <a:ext cx="0" cy="108000"/>
                </a:xfrm>
                <a:prstGeom prst="line">
                  <a:avLst/>
                </a:prstGeom>
                <a:ln w="285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" name="直接连接符 22"/>
                <p:cNvCxnSpPr>
                  <a:cxnSpLocks/>
                </p:cNvCxnSpPr>
                <p:nvPr/>
              </p:nvCxnSpPr>
              <p:spPr>
                <a:xfrm flipH="1">
                  <a:off x="1704124" y="1287168"/>
                  <a:ext cx="0" cy="108000"/>
                </a:xfrm>
                <a:prstGeom prst="line">
                  <a:avLst/>
                </a:prstGeom>
                <a:ln w="285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30" name="组合 29"/>
            <p:cNvGrpSpPr/>
            <p:nvPr/>
          </p:nvGrpSpPr>
          <p:grpSpPr>
            <a:xfrm>
              <a:off x="3894471" y="1615922"/>
              <a:ext cx="473475" cy="359087"/>
              <a:chOff x="1272217" y="983690"/>
              <a:chExt cx="473475" cy="359087"/>
            </a:xfrm>
          </p:grpSpPr>
          <p:sp>
            <p:nvSpPr>
              <p:cNvPr id="31" name="文本框 30"/>
              <p:cNvSpPr txBox="1"/>
              <p:nvPr/>
            </p:nvSpPr>
            <p:spPr>
              <a:xfrm flipH="1">
                <a:off x="1272217" y="983690"/>
                <a:ext cx="47347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32" name="组合 31"/>
              <p:cNvGrpSpPr/>
              <p:nvPr/>
            </p:nvGrpSpPr>
            <p:grpSpPr>
              <a:xfrm>
                <a:off x="1316764" y="1233556"/>
                <a:ext cx="396000" cy="109221"/>
                <a:chOff x="1316764" y="1285947"/>
                <a:chExt cx="396000" cy="109221"/>
              </a:xfrm>
            </p:grpSpPr>
            <p:cxnSp>
              <p:nvCxnSpPr>
                <p:cNvPr id="33" name="直接连接符 32"/>
                <p:cNvCxnSpPr>
                  <a:cxnSpLocks/>
                </p:cNvCxnSpPr>
                <p:nvPr/>
              </p:nvCxnSpPr>
              <p:spPr>
                <a:xfrm>
                  <a:off x="1316764" y="1289496"/>
                  <a:ext cx="396000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" name="直接连接符 33"/>
                <p:cNvCxnSpPr>
                  <a:cxnSpLocks/>
                </p:cNvCxnSpPr>
                <p:nvPr/>
              </p:nvCxnSpPr>
              <p:spPr>
                <a:xfrm flipH="1">
                  <a:off x="1331074" y="1285947"/>
                  <a:ext cx="0" cy="108000"/>
                </a:xfrm>
                <a:prstGeom prst="line">
                  <a:avLst/>
                </a:prstGeom>
                <a:ln w="285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" name="直接连接符 34"/>
                <p:cNvCxnSpPr>
                  <a:cxnSpLocks/>
                </p:cNvCxnSpPr>
                <p:nvPr/>
              </p:nvCxnSpPr>
              <p:spPr>
                <a:xfrm flipH="1">
                  <a:off x="1704124" y="1287168"/>
                  <a:ext cx="0" cy="108000"/>
                </a:xfrm>
                <a:prstGeom prst="line">
                  <a:avLst/>
                </a:prstGeom>
                <a:ln w="285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36" name="文本框 35"/>
            <p:cNvSpPr txBox="1"/>
            <p:nvPr/>
          </p:nvSpPr>
          <p:spPr>
            <a:xfrm flipH="1">
              <a:off x="3574431" y="1478762"/>
              <a:ext cx="47347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7" name="组合 36"/>
          <p:cNvGrpSpPr/>
          <p:nvPr/>
        </p:nvGrpSpPr>
        <p:grpSpPr>
          <a:xfrm>
            <a:off x="3112770" y="2490674"/>
            <a:ext cx="516036" cy="350246"/>
            <a:chOff x="1229656" y="983690"/>
            <a:chExt cx="516036" cy="350246"/>
          </a:xfrm>
        </p:grpSpPr>
        <p:sp>
          <p:nvSpPr>
            <p:cNvPr id="38" name="文本框 37"/>
            <p:cNvSpPr txBox="1"/>
            <p:nvPr/>
          </p:nvSpPr>
          <p:spPr>
            <a:xfrm flipH="1">
              <a:off x="1229656" y="983690"/>
              <a:ext cx="51603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9" name="组合 38"/>
            <p:cNvGrpSpPr/>
            <p:nvPr/>
          </p:nvGrpSpPr>
          <p:grpSpPr>
            <a:xfrm>
              <a:off x="1305334" y="1223347"/>
              <a:ext cx="360000" cy="110589"/>
              <a:chOff x="1305334" y="1275738"/>
              <a:chExt cx="360000" cy="110589"/>
            </a:xfrm>
          </p:grpSpPr>
          <p:cxnSp>
            <p:nvCxnSpPr>
              <p:cNvPr id="40" name="直接连接符 39"/>
              <p:cNvCxnSpPr>
                <a:cxnSpLocks/>
              </p:cNvCxnSpPr>
              <p:nvPr/>
            </p:nvCxnSpPr>
            <p:spPr>
              <a:xfrm>
                <a:off x="1305334" y="1281876"/>
                <a:ext cx="36000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直接连接符 40"/>
              <p:cNvCxnSpPr>
                <a:cxnSpLocks/>
              </p:cNvCxnSpPr>
              <p:nvPr/>
            </p:nvCxnSpPr>
            <p:spPr>
              <a:xfrm flipH="1">
                <a:off x="1312024" y="1278327"/>
                <a:ext cx="0" cy="108000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直接连接符 41"/>
              <p:cNvCxnSpPr>
                <a:cxnSpLocks/>
              </p:cNvCxnSpPr>
              <p:nvPr/>
            </p:nvCxnSpPr>
            <p:spPr>
              <a:xfrm flipH="1">
                <a:off x="1662214" y="1275738"/>
                <a:ext cx="0" cy="108000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pic>
        <p:nvPicPr>
          <p:cNvPr id="44" name="图片 43"/>
          <p:cNvPicPr>
            <a:picLocks noChangeAspect="1"/>
          </p:cNvPicPr>
          <p:nvPr/>
        </p:nvPicPr>
        <p:blipFill rotWithShape="1">
          <a:blip r:embed="rId3"/>
          <a:srcRect l="1627" t="89736" r="810" b="2095"/>
          <a:stretch/>
        </p:blipFill>
        <p:spPr>
          <a:xfrm>
            <a:off x="2071910" y="6635688"/>
            <a:ext cx="2846165" cy="205740"/>
          </a:xfrm>
          <a:prstGeom prst="rect">
            <a:avLst/>
          </a:prstGeom>
        </p:spPr>
      </p:pic>
      <p:sp>
        <p:nvSpPr>
          <p:cNvPr id="45" name="文本框 44"/>
          <p:cNvSpPr txBox="1"/>
          <p:nvPr/>
        </p:nvSpPr>
        <p:spPr>
          <a:xfrm flipH="1">
            <a:off x="2537460" y="2518410"/>
            <a:ext cx="5503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直接连接符 45"/>
          <p:cNvCxnSpPr>
            <a:cxnSpLocks/>
          </p:cNvCxnSpPr>
          <p:nvPr/>
        </p:nvCxnSpPr>
        <p:spPr>
          <a:xfrm>
            <a:off x="4426698" y="2824099"/>
            <a:ext cx="360000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接连接符 46"/>
          <p:cNvCxnSpPr>
            <a:cxnSpLocks/>
          </p:cNvCxnSpPr>
          <p:nvPr/>
        </p:nvCxnSpPr>
        <p:spPr>
          <a:xfrm flipH="1">
            <a:off x="4433388" y="2820550"/>
            <a:ext cx="0" cy="10800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接连接符 47"/>
          <p:cNvCxnSpPr>
            <a:cxnSpLocks/>
          </p:cNvCxnSpPr>
          <p:nvPr/>
        </p:nvCxnSpPr>
        <p:spPr>
          <a:xfrm flipH="1">
            <a:off x="4783578" y="2817961"/>
            <a:ext cx="0" cy="10800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文本框 48"/>
          <p:cNvSpPr txBox="1"/>
          <p:nvPr/>
        </p:nvSpPr>
        <p:spPr>
          <a:xfrm flipH="1">
            <a:off x="4328160" y="2579370"/>
            <a:ext cx="5503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直接连接符 49"/>
          <p:cNvCxnSpPr>
            <a:cxnSpLocks/>
          </p:cNvCxnSpPr>
          <p:nvPr/>
        </p:nvCxnSpPr>
        <p:spPr>
          <a:xfrm>
            <a:off x="2498838" y="2751709"/>
            <a:ext cx="612000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接连接符 50"/>
          <p:cNvCxnSpPr>
            <a:cxnSpLocks/>
          </p:cNvCxnSpPr>
          <p:nvPr/>
        </p:nvCxnSpPr>
        <p:spPr>
          <a:xfrm flipH="1">
            <a:off x="2513148" y="2748160"/>
            <a:ext cx="0" cy="10800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接连接符 51"/>
          <p:cNvCxnSpPr>
            <a:cxnSpLocks/>
          </p:cNvCxnSpPr>
          <p:nvPr/>
        </p:nvCxnSpPr>
        <p:spPr>
          <a:xfrm flipH="1">
            <a:off x="3099558" y="2745571"/>
            <a:ext cx="0" cy="10800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文本框 52"/>
          <p:cNvSpPr txBox="1"/>
          <p:nvPr/>
        </p:nvSpPr>
        <p:spPr>
          <a:xfrm flipH="1">
            <a:off x="3604911" y="2804642"/>
            <a:ext cx="4734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直接连接符 54"/>
          <p:cNvCxnSpPr>
            <a:cxnSpLocks/>
          </p:cNvCxnSpPr>
          <p:nvPr/>
        </p:nvCxnSpPr>
        <p:spPr>
          <a:xfrm>
            <a:off x="3969498" y="3576217"/>
            <a:ext cx="396000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接连接符 55"/>
          <p:cNvCxnSpPr>
            <a:cxnSpLocks/>
          </p:cNvCxnSpPr>
          <p:nvPr/>
        </p:nvCxnSpPr>
        <p:spPr>
          <a:xfrm flipH="1">
            <a:off x="3983808" y="3572668"/>
            <a:ext cx="0" cy="10800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接连接符 56"/>
          <p:cNvCxnSpPr>
            <a:cxnSpLocks/>
          </p:cNvCxnSpPr>
          <p:nvPr/>
        </p:nvCxnSpPr>
        <p:spPr>
          <a:xfrm flipH="1">
            <a:off x="4356858" y="3573889"/>
            <a:ext cx="0" cy="10800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文本框 57"/>
          <p:cNvSpPr txBox="1"/>
          <p:nvPr/>
        </p:nvSpPr>
        <p:spPr>
          <a:xfrm flipH="1">
            <a:off x="3918003" y="3329687"/>
            <a:ext cx="4734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9" name="组合 58"/>
          <p:cNvGrpSpPr/>
          <p:nvPr/>
        </p:nvGrpSpPr>
        <p:grpSpPr>
          <a:xfrm>
            <a:off x="4443628" y="5401141"/>
            <a:ext cx="473475" cy="351467"/>
            <a:chOff x="910267" y="991310"/>
            <a:chExt cx="473475" cy="351467"/>
          </a:xfrm>
        </p:grpSpPr>
        <p:sp>
          <p:nvSpPr>
            <p:cNvPr id="60" name="文本框 59"/>
            <p:cNvSpPr txBox="1"/>
            <p:nvPr/>
          </p:nvSpPr>
          <p:spPr>
            <a:xfrm flipH="1">
              <a:off x="910267" y="991310"/>
              <a:ext cx="47347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1" name="组合 60"/>
            <p:cNvGrpSpPr/>
            <p:nvPr/>
          </p:nvGrpSpPr>
          <p:grpSpPr>
            <a:xfrm>
              <a:off x="992914" y="1233556"/>
              <a:ext cx="288300" cy="109221"/>
              <a:chOff x="992914" y="1285947"/>
              <a:chExt cx="288300" cy="109221"/>
            </a:xfrm>
          </p:grpSpPr>
          <p:cxnSp>
            <p:nvCxnSpPr>
              <p:cNvPr id="62" name="直接连接符 61"/>
              <p:cNvCxnSpPr>
                <a:cxnSpLocks/>
              </p:cNvCxnSpPr>
              <p:nvPr/>
            </p:nvCxnSpPr>
            <p:spPr>
              <a:xfrm>
                <a:off x="992914" y="1289496"/>
                <a:ext cx="28800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直接连接符 62"/>
              <p:cNvCxnSpPr>
                <a:cxnSpLocks/>
              </p:cNvCxnSpPr>
              <p:nvPr/>
            </p:nvCxnSpPr>
            <p:spPr>
              <a:xfrm flipH="1">
                <a:off x="995794" y="1285947"/>
                <a:ext cx="0" cy="108000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直接连接符 63"/>
              <p:cNvCxnSpPr>
                <a:cxnSpLocks/>
              </p:cNvCxnSpPr>
              <p:nvPr/>
            </p:nvCxnSpPr>
            <p:spPr>
              <a:xfrm flipH="1">
                <a:off x="1281214" y="1287168"/>
                <a:ext cx="0" cy="108000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65" name="组合 64"/>
          <p:cNvGrpSpPr/>
          <p:nvPr/>
        </p:nvGrpSpPr>
        <p:grpSpPr>
          <a:xfrm>
            <a:off x="4078386" y="5663772"/>
            <a:ext cx="473475" cy="351467"/>
            <a:chOff x="940747" y="991310"/>
            <a:chExt cx="473475" cy="351467"/>
          </a:xfrm>
        </p:grpSpPr>
        <p:sp>
          <p:nvSpPr>
            <p:cNvPr id="66" name="文本框 65"/>
            <p:cNvSpPr txBox="1"/>
            <p:nvPr/>
          </p:nvSpPr>
          <p:spPr>
            <a:xfrm flipH="1">
              <a:off x="940747" y="991310"/>
              <a:ext cx="47347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7" name="组合 66"/>
            <p:cNvGrpSpPr/>
            <p:nvPr/>
          </p:nvGrpSpPr>
          <p:grpSpPr>
            <a:xfrm>
              <a:off x="977674" y="1233556"/>
              <a:ext cx="406410" cy="109221"/>
              <a:chOff x="977674" y="1285947"/>
              <a:chExt cx="406410" cy="109221"/>
            </a:xfrm>
          </p:grpSpPr>
          <p:cxnSp>
            <p:nvCxnSpPr>
              <p:cNvPr id="68" name="直接连接符 67"/>
              <p:cNvCxnSpPr>
                <a:cxnSpLocks/>
              </p:cNvCxnSpPr>
              <p:nvPr/>
            </p:nvCxnSpPr>
            <p:spPr>
              <a:xfrm>
                <a:off x="977674" y="1289496"/>
                <a:ext cx="39600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直接连接符 68"/>
              <p:cNvCxnSpPr>
                <a:cxnSpLocks/>
              </p:cNvCxnSpPr>
              <p:nvPr/>
            </p:nvCxnSpPr>
            <p:spPr>
              <a:xfrm flipH="1">
                <a:off x="984364" y="1285947"/>
                <a:ext cx="0" cy="108000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直接连接符 69"/>
              <p:cNvCxnSpPr>
                <a:cxnSpLocks/>
              </p:cNvCxnSpPr>
              <p:nvPr/>
            </p:nvCxnSpPr>
            <p:spPr>
              <a:xfrm flipH="1">
                <a:off x="1384084" y="1287168"/>
                <a:ext cx="0" cy="108000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71" name="组合 70"/>
          <p:cNvGrpSpPr/>
          <p:nvPr/>
        </p:nvGrpSpPr>
        <p:grpSpPr>
          <a:xfrm>
            <a:off x="3278240" y="5821100"/>
            <a:ext cx="720000" cy="351467"/>
            <a:chOff x="909094" y="991310"/>
            <a:chExt cx="720000" cy="351467"/>
          </a:xfrm>
        </p:grpSpPr>
        <p:sp>
          <p:nvSpPr>
            <p:cNvPr id="72" name="文本框 71"/>
            <p:cNvSpPr txBox="1"/>
            <p:nvPr/>
          </p:nvSpPr>
          <p:spPr>
            <a:xfrm flipH="1">
              <a:off x="1028377" y="991310"/>
              <a:ext cx="47347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3" name="组合 72"/>
            <p:cNvGrpSpPr/>
            <p:nvPr/>
          </p:nvGrpSpPr>
          <p:grpSpPr>
            <a:xfrm>
              <a:off x="909094" y="1233556"/>
              <a:ext cx="720000" cy="109221"/>
              <a:chOff x="909094" y="1285947"/>
              <a:chExt cx="720000" cy="109221"/>
            </a:xfrm>
          </p:grpSpPr>
          <p:cxnSp>
            <p:nvCxnSpPr>
              <p:cNvPr id="74" name="直接连接符 73"/>
              <p:cNvCxnSpPr>
                <a:cxnSpLocks/>
              </p:cNvCxnSpPr>
              <p:nvPr/>
            </p:nvCxnSpPr>
            <p:spPr>
              <a:xfrm>
                <a:off x="909094" y="1289496"/>
                <a:ext cx="72000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直接连接符 74"/>
              <p:cNvCxnSpPr>
                <a:cxnSpLocks/>
              </p:cNvCxnSpPr>
              <p:nvPr/>
            </p:nvCxnSpPr>
            <p:spPr>
              <a:xfrm flipH="1">
                <a:off x="919594" y="1285947"/>
                <a:ext cx="0" cy="108000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直接连接符 75"/>
              <p:cNvCxnSpPr>
                <a:cxnSpLocks/>
              </p:cNvCxnSpPr>
              <p:nvPr/>
            </p:nvCxnSpPr>
            <p:spPr>
              <a:xfrm flipH="1">
                <a:off x="1616494" y="1287168"/>
                <a:ext cx="0" cy="108000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77" name="组合 76"/>
          <p:cNvGrpSpPr/>
          <p:nvPr/>
        </p:nvGrpSpPr>
        <p:grpSpPr>
          <a:xfrm>
            <a:off x="2470520" y="4594280"/>
            <a:ext cx="720000" cy="459467"/>
            <a:chOff x="909094" y="991310"/>
            <a:chExt cx="720000" cy="459467"/>
          </a:xfrm>
        </p:grpSpPr>
        <p:sp>
          <p:nvSpPr>
            <p:cNvPr id="78" name="文本框 77"/>
            <p:cNvSpPr txBox="1"/>
            <p:nvPr/>
          </p:nvSpPr>
          <p:spPr>
            <a:xfrm flipH="1">
              <a:off x="1028377" y="991310"/>
              <a:ext cx="47347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9" name="组合 78"/>
            <p:cNvGrpSpPr/>
            <p:nvPr/>
          </p:nvGrpSpPr>
          <p:grpSpPr>
            <a:xfrm>
              <a:off x="909094" y="1233556"/>
              <a:ext cx="720000" cy="217221"/>
              <a:chOff x="909094" y="1285947"/>
              <a:chExt cx="720000" cy="217221"/>
            </a:xfrm>
          </p:grpSpPr>
          <p:cxnSp>
            <p:nvCxnSpPr>
              <p:cNvPr id="80" name="直接连接符 79"/>
              <p:cNvCxnSpPr>
                <a:cxnSpLocks/>
              </p:cNvCxnSpPr>
              <p:nvPr/>
            </p:nvCxnSpPr>
            <p:spPr>
              <a:xfrm>
                <a:off x="909094" y="1289496"/>
                <a:ext cx="72000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直接连接符 80"/>
              <p:cNvCxnSpPr>
                <a:cxnSpLocks/>
              </p:cNvCxnSpPr>
              <p:nvPr/>
            </p:nvCxnSpPr>
            <p:spPr>
              <a:xfrm flipH="1">
                <a:off x="919594" y="1285947"/>
                <a:ext cx="0" cy="216000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直接连接符 81"/>
              <p:cNvCxnSpPr>
                <a:cxnSpLocks/>
              </p:cNvCxnSpPr>
              <p:nvPr/>
            </p:nvCxnSpPr>
            <p:spPr>
              <a:xfrm flipH="1">
                <a:off x="1616494" y="1287168"/>
                <a:ext cx="0" cy="216000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xmlns="" val="181597913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632434" y="5261579"/>
            <a:ext cx="5593132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4. Effects of </a:t>
            </a:r>
            <a:r>
              <a:rPr lang="en-US" altLang="zh-CN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HtNHX1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zh-CN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HtNHX2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expression on ammonium N acquisition and distribution under low N and K supply condition. </a:t>
            </a:r>
          </a:p>
          <a:p>
            <a:pPr algn="just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he rice seedlings were grown in 0.3mM (NH4)</a:t>
            </a:r>
            <a:r>
              <a:rPr lang="en-US" altLang="zh-CN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O</a:t>
            </a:r>
            <a:r>
              <a:rPr lang="en-US" altLang="zh-CN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and 0.25mM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Cl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solution for two weeks and then </a:t>
            </a:r>
            <a:r>
              <a:rPr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 labelled (</a:t>
            </a:r>
            <a:r>
              <a:rPr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H</a:t>
            </a:r>
            <a:r>
              <a:rPr lang="en-US" altLang="zh-CN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altLang="zh-CN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O</a:t>
            </a:r>
            <a:r>
              <a:rPr lang="en-US" altLang="zh-CN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was presented in the culture solution for 24h for analyzing </a:t>
            </a:r>
            <a:r>
              <a:rPr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 concentration in the root and shoot. Different letter on the column indicates the significant difference at probability at 5%. ns: no significant difference.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24768" y="2315711"/>
            <a:ext cx="2805264" cy="2683777"/>
          </a:xfrm>
          <a:prstGeom prst="rect">
            <a:avLst/>
          </a:prstGeom>
        </p:spPr>
      </p:pic>
      <p:grpSp>
        <p:nvGrpSpPr>
          <p:cNvPr id="4" name="组合 3"/>
          <p:cNvGrpSpPr/>
          <p:nvPr/>
        </p:nvGrpSpPr>
        <p:grpSpPr>
          <a:xfrm>
            <a:off x="2527670" y="3188390"/>
            <a:ext cx="972000" cy="347657"/>
            <a:chOff x="909094" y="995120"/>
            <a:chExt cx="972000" cy="347657"/>
          </a:xfrm>
        </p:grpSpPr>
        <p:sp>
          <p:nvSpPr>
            <p:cNvPr id="6" name="文本框 5"/>
            <p:cNvSpPr txBox="1"/>
            <p:nvPr/>
          </p:nvSpPr>
          <p:spPr>
            <a:xfrm flipH="1">
              <a:off x="1161727" y="995120"/>
              <a:ext cx="47347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" name="组合 6"/>
            <p:cNvGrpSpPr/>
            <p:nvPr/>
          </p:nvGrpSpPr>
          <p:grpSpPr>
            <a:xfrm>
              <a:off x="909094" y="1233556"/>
              <a:ext cx="972000" cy="109221"/>
              <a:chOff x="909094" y="1285947"/>
              <a:chExt cx="972000" cy="109221"/>
            </a:xfrm>
          </p:grpSpPr>
          <p:cxnSp>
            <p:nvCxnSpPr>
              <p:cNvPr id="8" name="直接连接符 7"/>
              <p:cNvCxnSpPr>
                <a:cxnSpLocks/>
              </p:cNvCxnSpPr>
              <p:nvPr/>
            </p:nvCxnSpPr>
            <p:spPr>
              <a:xfrm>
                <a:off x="909094" y="1289496"/>
                <a:ext cx="97200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直接连接符 8"/>
              <p:cNvCxnSpPr>
                <a:cxnSpLocks/>
              </p:cNvCxnSpPr>
              <p:nvPr/>
            </p:nvCxnSpPr>
            <p:spPr>
              <a:xfrm flipH="1">
                <a:off x="919594" y="1285947"/>
                <a:ext cx="0" cy="108000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直接连接符 9"/>
              <p:cNvCxnSpPr>
                <a:cxnSpLocks/>
              </p:cNvCxnSpPr>
              <p:nvPr/>
            </p:nvCxnSpPr>
            <p:spPr>
              <a:xfrm flipH="1">
                <a:off x="1867954" y="1287168"/>
                <a:ext cx="0" cy="108000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1" name="组合 10"/>
          <p:cNvGrpSpPr/>
          <p:nvPr/>
        </p:nvGrpSpPr>
        <p:grpSpPr>
          <a:xfrm>
            <a:off x="4038600" y="2315711"/>
            <a:ext cx="727748" cy="351467"/>
            <a:chOff x="774104" y="991310"/>
            <a:chExt cx="727748" cy="351467"/>
          </a:xfrm>
        </p:grpSpPr>
        <p:sp>
          <p:nvSpPr>
            <p:cNvPr id="12" name="文本框 11"/>
            <p:cNvSpPr txBox="1"/>
            <p:nvPr/>
          </p:nvSpPr>
          <p:spPr>
            <a:xfrm flipH="1">
              <a:off x="774104" y="991310"/>
              <a:ext cx="72774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" name="组合 12"/>
            <p:cNvGrpSpPr/>
            <p:nvPr/>
          </p:nvGrpSpPr>
          <p:grpSpPr>
            <a:xfrm>
              <a:off x="909094" y="1233556"/>
              <a:ext cx="432000" cy="109221"/>
              <a:chOff x="909094" y="1285947"/>
              <a:chExt cx="432000" cy="109221"/>
            </a:xfrm>
          </p:grpSpPr>
          <p:cxnSp>
            <p:nvCxnSpPr>
              <p:cNvPr id="14" name="直接连接符 13"/>
              <p:cNvCxnSpPr>
                <a:cxnSpLocks/>
              </p:cNvCxnSpPr>
              <p:nvPr/>
            </p:nvCxnSpPr>
            <p:spPr>
              <a:xfrm>
                <a:off x="909094" y="1289496"/>
                <a:ext cx="43200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直接连接符 14"/>
              <p:cNvCxnSpPr>
                <a:cxnSpLocks/>
              </p:cNvCxnSpPr>
              <p:nvPr/>
            </p:nvCxnSpPr>
            <p:spPr>
              <a:xfrm flipH="1">
                <a:off x="919594" y="1285947"/>
                <a:ext cx="0" cy="108000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直接连接符 15"/>
              <p:cNvCxnSpPr>
                <a:cxnSpLocks/>
              </p:cNvCxnSpPr>
              <p:nvPr/>
            </p:nvCxnSpPr>
            <p:spPr>
              <a:xfrm flipH="1">
                <a:off x="1330744" y="1287168"/>
                <a:ext cx="0" cy="108000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7" name="文本框 16"/>
          <p:cNvSpPr txBox="1"/>
          <p:nvPr/>
        </p:nvSpPr>
        <p:spPr>
          <a:xfrm flipH="1">
            <a:off x="3569970" y="2781601"/>
            <a:ext cx="3009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 flipH="1">
            <a:off x="3962400" y="2785411"/>
            <a:ext cx="3009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 flipH="1">
            <a:off x="3756660" y="2998771"/>
            <a:ext cx="3009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7114009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文本框 43"/>
          <p:cNvSpPr txBox="1"/>
          <p:nvPr/>
        </p:nvSpPr>
        <p:spPr>
          <a:xfrm>
            <a:off x="454418" y="4936038"/>
            <a:ext cx="5919775" cy="14619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Bef>
                <a:spcPts val="600"/>
              </a:spcBef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5. HtNHX1, but not HtNHX2, functioned in enhancing tolerance to external hygromycin in both nhx1 mutated yeast cells (A) and Arabidopsis (B).</a:t>
            </a:r>
          </a:p>
          <a:p>
            <a:pPr algn="just">
              <a:spcBef>
                <a:spcPts val="600"/>
              </a:spcBef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he seeds of WT and nhx5:6 were germinated in normal ½ MS medium for one week, while the seeds of the transgenic lines expressing HtNHX1 or HtNHX2 were germinated in the ½ MS medium containing 25 mg/L hygromycin for one week, then all the seedlings were transplanted in the culture medium in a greenhouse for 6 weeks before being photographed.</a:t>
            </a:r>
          </a:p>
        </p:txBody>
      </p:sp>
      <p:grpSp>
        <p:nvGrpSpPr>
          <p:cNvPr id="19" name="组合 18"/>
          <p:cNvGrpSpPr/>
          <p:nvPr/>
        </p:nvGrpSpPr>
        <p:grpSpPr>
          <a:xfrm>
            <a:off x="356235" y="1427228"/>
            <a:ext cx="5907710" cy="3191572"/>
            <a:chOff x="537210" y="1427228"/>
            <a:chExt cx="5907710" cy="3191572"/>
          </a:xfrm>
        </p:grpSpPr>
        <p:grpSp>
          <p:nvGrpSpPr>
            <p:cNvPr id="3" name="组合 2"/>
            <p:cNvGrpSpPr/>
            <p:nvPr/>
          </p:nvGrpSpPr>
          <p:grpSpPr>
            <a:xfrm>
              <a:off x="851553" y="1427228"/>
              <a:ext cx="5593367" cy="1083696"/>
              <a:chOff x="1122063" y="741428"/>
              <a:chExt cx="5593367" cy="1083696"/>
            </a:xfrm>
          </p:grpSpPr>
          <p:grpSp>
            <p:nvGrpSpPr>
              <p:cNvPr id="2" name="组合 1"/>
              <p:cNvGrpSpPr/>
              <p:nvPr/>
            </p:nvGrpSpPr>
            <p:grpSpPr>
              <a:xfrm>
                <a:off x="1122063" y="741428"/>
                <a:ext cx="5593367" cy="1083696"/>
                <a:chOff x="956688" y="772198"/>
                <a:chExt cx="5593367" cy="1083696"/>
              </a:xfrm>
            </p:grpSpPr>
            <p:pic>
              <p:nvPicPr>
                <p:cNvPr id="4" name="Picture 3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extLst>
                    <a:ext uri="{BEBA8EAE-BF5A-486C-A8C5-ECC9F3942E4B}">
                      <a14:imgProps xmlns:a14="http://schemas.microsoft.com/office/drawing/2010/main" xmlns="">
                        <a14:imgLayer r:embed="rId4">
                          <a14:imgEffect>
                            <a14:saturation sat="0"/>
                          </a14:imgEffect>
                          <a14:imgEffect>
                            <a14:brightnessContrast bright="4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968240" y="782093"/>
                  <a:ext cx="1581815" cy="8280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 xmlns="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5" name="TextBox 4"/>
                <p:cNvSpPr txBox="1"/>
                <p:nvPr/>
              </p:nvSpPr>
              <p:spPr>
                <a:xfrm>
                  <a:off x="5037486" y="1586664"/>
                  <a:ext cx="1473480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zh-CN" sz="10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0</a:t>
                  </a:r>
                  <a:r>
                    <a:rPr lang="el-GR" altLang="zh-CN" sz="10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lang="en-US" altLang="zh-CN" sz="10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/ml  Higromycin</a:t>
                  </a:r>
                  <a:endParaRPr lang="zh-CN" altLang="en-US" sz="105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" name="TextBox 5"/>
                <p:cNvSpPr txBox="1"/>
                <p:nvPr/>
              </p:nvSpPr>
              <p:spPr>
                <a:xfrm>
                  <a:off x="992487" y="772198"/>
                  <a:ext cx="604653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Vector</a:t>
                  </a:r>
                  <a:endParaRPr lang="zh-CN" altLang="en-US" sz="105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" name="TextBox 6"/>
                <p:cNvSpPr txBox="1"/>
                <p:nvPr/>
              </p:nvSpPr>
              <p:spPr>
                <a:xfrm>
                  <a:off x="956688" y="1048608"/>
                  <a:ext cx="688009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tNHX1</a:t>
                  </a:r>
                  <a:endParaRPr lang="zh-CN" altLang="en-US" sz="105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" name="TextBox 7"/>
                <p:cNvSpPr txBox="1"/>
                <p:nvPr/>
              </p:nvSpPr>
              <p:spPr>
                <a:xfrm>
                  <a:off x="956688" y="1340780"/>
                  <a:ext cx="688009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tNHX2</a:t>
                  </a:r>
                  <a:endParaRPr lang="zh-CN" altLang="en-US" sz="105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10" name="Picture 2"/>
                <p:cNvPicPr>
                  <a:picLocks noChangeAspect="1" noChangeArrowheads="1"/>
                </p:cNvPicPr>
                <p:nvPr/>
              </p:nvPicPr>
              <p:blipFill>
                <a:blip r:embed="rId5" cstate="print">
                  <a:grayscl/>
                  <a:extLst>
                    <a:ext uri="{BEBA8EAE-BF5A-486C-A8C5-ECC9F3942E4B}">
                      <a14:imgProps xmlns:a14="http://schemas.microsoft.com/office/drawing/2010/main" xmlns="">
                        <a14:imgLayer r:embed="rId6">
                          <a14:imgEffect>
                            <a14:colorTemperature colorTemp="5300"/>
                          </a14:imgEffect>
                          <a14:imgEffect>
                            <a14:saturation sat="0"/>
                          </a14:imgEffect>
                          <a14:imgEffect>
                            <a14:brightnessContrast bright="-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 rot="5400000" flipH="1">
                  <a:off x="2033401" y="375513"/>
                  <a:ext cx="828000" cy="164116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 xmlns="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42" name="TextBox 4"/>
                <p:cNvSpPr txBox="1"/>
                <p:nvPr/>
              </p:nvSpPr>
              <p:spPr>
                <a:xfrm>
                  <a:off x="1721233" y="1594284"/>
                  <a:ext cx="1433405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zh-CN" sz="10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 </a:t>
                  </a:r>
                  <a:r>
                    <a:rPr lang="el-GR" altLang="zh-CN" sz="10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lang="en-US" altLang="zh-CN" sz="10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/ml  Higromycin</a:t>
                  </a:r>
                  <a:endParaRPr lang="zh-CN" altLang="en-US" sz="105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11" name="Picture 4"/>
              <p:cNvPicPr>
                <a:picLocks noChangeAspect="1" noChangeArrowheads="1"/>
              </p:cNvPicPr>
              <p:nvPr/>
            </p:nvPicPr>
            <p:blipFill rotWithShape="1">
              <a:blip r:embed="rId7" cstate="print">
                <a:grayscl/>
                <a:extLst>
                  <a:ext uri="{BEBA8EAE-BF5A-486C-A8C5-ECC9F3942E4B}">
                    <a14:imgProps xmlns:a14="http://schemas.microsoft.com/office/drawing/2010/main" xmlns="">
                      <a14:imgLayer r:embed="rId8">
                        <a14:imgEffect>
                          <a14:colorTemperature colorTemp="5300"/>
                        </a14:imgEffect>
                        <a14:imgEffect>
                          <a14:saturation sat="0"/>
                        </a14:imgEffect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5269" t="-178" r="5084"/>
              <a:stretch/>
            </p:blipFill>
            <p:spPr bwMode="auto">
              <a:xfrm rot="5400000">
                <a:off x="3868201" y="415732"/>
                <a:ext cx="835686" cy="150686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2" name="TextBox 4"/>
              <p:cNvSpPr txBox="1"/>
              <p:nvPr/>
            </p:nvSpPr>
            <p:spPr>
              <a:xfrm>
                <a:off x="3540431" y="1563514"/>
                <a:ext cx="147348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r>
                  <a:rPr lang="el-GR" altLang="zh-CN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μ</a:t>
                </a:r>
                <a:r>
                  <a:rPr lang="en-US" altLang="zh-CN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g/ml  Higromycin</a:t>
                </a:r>
                <a:endParaRPr lang="zh-CN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3" name="组合 12"/>
            <p:cNvGrpSpPr/>
            <p:nvPr/>
          </p:nvGrpSpPr>
          <p:grpSpPr>
            <a:xfrm>
              <a:off x="920211" y="2900060"/>
              <a:ext cx="1798802" cy="1718740"/>
              <a:chOff x="664941" y="2854633"/>
              <a:chExt cx="1798802" cy="1718740"/>
            </a:xfrm>
          </p:grpSpPr>
          <p:pic>
            <p:nvPicPr>
              <p:cNvPr id="14" name="Picture 4"/>
              <p:cNvPicPr>
                <a:picLocks noChangeAspect="1" noChangeArrowheads="1"/>
              </p:cNvPicPr>
              <p:nvPr/>
            </p:nvPicPr>
            <p:blipFill rotWithShape="1">
              <a:blip r:embed="rId9" cstate="print">
                <a:extLst>
                  <a:ext uri="{BEBA8EAE-BF5A-486C-A8C5-ECC9F3942E4B}">
                    <a14:imgProps xmlns:a14="http://schemas.microsoft.com/office/drawing/2010/main" xmlns="">
                      <a14:imgLayer r:embed="rId10">
                        <a14:imgEffect>
                          <a14:brightnessContrast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/>
              <a:stretch/>
            </p:blipFill>
            <p:spPr bwMode="auto">
              <a:xfrm>
                <a:off x="664941" y="2854633"/>
                <a:ext cx="1742341" cy="166092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9" name="文本框 8"/>
              <p:cNvSpPr txBox="1"/>
              <p:nvPr/>
            </p:nvSpPr>
            <p:spPr>
              <a:xfrm>
                <a:off x="986098" y="3473563"/>
                <a:ext cx="40427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5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zh-CN" altLang="en-US" sz="105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文本框 15"/>
              <p:cNvSpPr txBox="1"/>
              <p:nvPr/>
            </p:nvSpPr>
            <p:spPr>
              <a:xfrm>
                <a:off x="1543628" y="3469118"/>
                <a:ext cx="90297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5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hx5:6</a:t>
                </a:r>
                <a:endParaRPr lang="zh-CN" altLang="en-US" sz="1050" b="1" i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文本框 16"/>
              <p:cNvSpPr txBox="1"/>
              <p:nvPr/>
            </p:nvSpPr>
            <p:spPr>
              <a:xfrm>
                <a:off x="730828" y="4311763"/>
                <a:ext cx="90297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5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tNHX1</a:t>
                </a:r>
                <a:endParaRPr lang="zh-CN" altLang="en-US" sz="1050" b="1" i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文本框 17"/>
              <p:cNvSpPr txBox="1"/>
              <p:nvPr/>
            </p:nvSpPr>
            <p:spPr>
              <a:xfrm>
                <a:off x="1560773" y="4311763"/>
                <a:ext cx="90297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5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tNHX2</a:t>
                </a:r>
                <a:endParaRPr lang="zh-CN" altLang="en-US" sz="1050" b="1" i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" name="文本框 14"/>
            <p:cNvSpPr txBox="1"/>
            <p:nvPr/>
          </p:nvSpPr>
          <p:spPr>
            <a:xfrm>
              <a:off x="552450" y="1680778"/>
              <a:ext cx="32533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537210" y="3532438"/>
              <a:ext cx="32533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20" name="图片 19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072536" y="3077314"/>
            <a:ext cx="3219986" cy="1460733"/>
          </a:xfrm>
          <a:prstGeom prst="rect">
            <a:avLst/>
          </a:prstGeom>
        </p:spPr>
      </p:pic>
      <p:sp>
        <p:nvSpPr>
          <p:cNvPr id="24" name="TextBox 15"/>
          <p:cNvSpPr txBox="1"/>
          <p:nvPr/>
        </p:nvSpPr>
        <p:spPr>
          <a:xfrm>
            <a:off x="2698529" y="3118033"/>
            <a:ext cx="39305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16"/>
          <p:cNvSpPr txBox="1"/>
          <p:nvPr/>
        </p:nvSpPr>
        <p:spPr>
          <a:xfrm>
            <a:off x="2516247" y="3496773"/>
            <a:ext cx="61908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nhx5:6</a:t>
            </a:r>
            <a:endParaRPr lang="zh-CN" altLang="en-US" sz="105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17"/>
          <p:cNvSpPr txBox="1"/>
          <p:nvPr/>
        </p:nvSpPr>
        <p:spPr>
          <a:xfrm>
            <a:off x="2446400" y="3857496"/>
            <a:ext cx="68800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HtNHX1</a:t>
            </a:r>
            <a:endParaRPr lang="zh-CN" altLang="en-US" sz="105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18"/>
          <p:cNvSpPr txBox="1"/>
          <p:nvPr/>
        </p:nvSpPr>
        <p:spPr>
          <a:xfrm>
            <a:off x="2452413" y="4250920"/>
            <a:ext cx="68800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HtNHX2</a:t>
            </a:r>
            <a:endParaRPr lang="zh-CN" altLang="en-US" sz="105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4"/>
          <p:cNvSpPr txBox="1"/>
          <p:nvPr/>
        </p:nvSpPr>
        <p:spPr>
          <a:xfrm>
            <a:off x="3152546" y="2836517"/>
            <a:ext cx="14334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el-GR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g/ml  Hygromycin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4"/>
          <p:cNvSpPr txBox="1"/>
          <p:nvPr/>
        </p:nvSpPr>
        <p:spPr>
          <a:xfrm>
            <a:off x="4743133" y="2829428"/>
            <a:ext cx="14911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l-GR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g/ml  Hygromycin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5370923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11335" y="556622"/>
            <a:ext cx="5554186" cy="537553"/>
          </a:xfrm>
        </p:spPr>
        <p:txBody>
          <a:bodyPr>
            <a:norm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1. The primers used in the experiments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0" name="表格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344776708"/>
              </p:ext>
            </p:extLst>
          </p:nvPr>
        </p:nvGraphicFramePr>
        <p:xfrm>
          <a:off x="646112" y="4027242"/>
          <a:ext cx="5380038" cy="120015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471101"/>
                <a:gridCol w="3908937"/>
              </a:tblGrid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 name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 (5</a:t>
                      </a:r>
                      <a:r>
                        <a:rPr lang="en-US" sz="105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' to </a:t>
                      </a:r>
                      <a:r>
                        <a:rPr lang="en-US" sz="1050" kern="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’)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CK303-HtNHX-F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CK303-HtNHX-R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tNHX-pyes2.0-F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tNHX-pyes2.0-R 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CGGAT CCATGGTGTTTGATATGGGATTAATG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CGAGCTCCTAGTTTCCGGTGGTTTCTTCA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GCTTAACACAATGTCTATGGTGTTTGATATGGGATTAAT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CGAATTCCTAGTTTCCGGTGGTTTCTTCAT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</a:tr>
            </a:tbl>
          </a:graphicData>
        </a:graphic>
      </p:graphicFrame>
      <p:sp>
        <p:nvSpPr>
          <p:cNvPr id="11" name="Rectangle 3"/>
          <p:cNvSpPr>
            <a:spLocks noChangeArrowheads="1"/>
          </p:cNvSpPr>
          <p:nvPr/>
        </p:nvSpPr>
        <p:spPr bwMode="auto">
          <a:xfrm>
            <a:off x="574834" y="3750243"/>
            <a:ext cx="5172393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he primers for </a:t>
            </a:r>
            <a:r>
              <a:rPr kumimoji="0" lang="en-US" altLang="zh-CN" sz="120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HtNHX1/2</a:t>
            </a:r>
            <a:r>
              <a:rPr kumimoji="0" lang="en-US" altLang="zh-CN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-cDNA for construction of overexpression</a:t>
            </a:r>
            <a:endParaRPr kumimoji="0" lang="en-US" altLang="zh-CN" sz="28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609600" y="5400856"/>
            <a:ext cx="4767202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he primers for </a:t>
            </a:r>
            <a:r>
              <a:rPr lang="en-US" altLang="zh-CN" sz="1200" i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HtNHX1/2</a:t>
            </a:r>
            <a:r>
              <a:rPr lang="en-US" altLang="zh-CN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-cDNA for construction of </a:t>
            </a:r>
            <a:r>
              <a:rPr lang="en-US" altLang="zh-CN" sz="1200" dirty="0" smtClean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ub-localization</a:t>
            </a:r>
            <a:endParaRPr lang="zh-CN" altLang="zh-CN" sz="120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graphicFrame>
        <p:nvGraphicFramePr>
          <p:cNvPr id="13" name="表格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390441598"/>
              </p:ext>
            </p:extLst>
          </p:nvPr>
        </p:nvGraphicFramePr>
        <p:xfrm>
          <a:off x="646112" y="5715494"/>
          <a:ext cx="5535232" cy="216027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045795"/>
                <a:gridCol w="4489437"/>
              </a:tblGrid>
              <a:tr h="174442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 name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 (5</a:t>
                      </a:r>
                      <a:r>
                        <a:rPr lang="en-US" sz="105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' to </a:t>
                      </a:r>
                      <a:r>
                        <a:rPr lang="en-US" sz="1050" kern="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’)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</a:tr>
              <a:tr h="166135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tNHX</a:t>
                      </a:r>
                      <a:r>
                        <a:rPr lang="en-US" sz="105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N-F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GGAATTCATGGTGTTTGATATGGGATTAATG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</a:tr>
              <a:tr h="166135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tNHX-N-R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CGGATCCGGTTTCCGGTGGTTTCTTCATCA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</a:tr>
              <a:tr h="166135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tNHX-C-F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GGAATTCGATGGTGTTTGATATGGGATTAATG 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</a:tr>
              <a:tr h="166135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tNHX-C-R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CGGATCCCTAGTTTCCGGTGGTTTCTTC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</a:tr>
              <a:tr h="166135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tNHX1-Del-R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ATAGAATTGCACTGTCTTTCACAAAGCTCCATTTTTC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</a:tr>
              <a:tr h="166135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tNHX1-Del-F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TTTGTGAAAGACAGTGCAATTCTATTGGGCTTGG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</a:tr>
              <a:tr h="166135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tNHX2-Cp-R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CTTCAGCTGATGTCCCCGGGCTCTCAGCTAGCATGTAAGAAAG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</a:tr>
              <a:tr h="166135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tNHX2-Cp-F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CCCGGGGACATCAGCTGAAGTGGTTTTAATATGGTGGGCTGGTC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</a:tr>
            </a:tbl>
          </a:graphicData>
        </a:graphic>
      </p:graphicFrame>
      <p:sp>
        <p:nvSpPr>
          <p:cNvPr id="14" name="矩形 13"/>
          <p:cNvSpPr/>
          <p:nvPr/>
        </p:nvSpPr>
        <p:spPr>
          <a:xfrm>
            <a:off x="609600" y="7930188"/>
            <a:ext cx="3429000" cy="253916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05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Del</a:t>
            </a:r>
            <a:r>
              <a:rPr lang="zh-CN" altLang="zh-CN" sz="105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：</a:t>
            </a:r>
            <a:r>
              <a:rPr lang="en-US" altLang="zh-CN" sz="105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deletion. </a:t>
            </a:r>
            <a:r>
              <a:rPr lang="en-US" altLang="zh-CN" sz="1050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p</a:t>
            </a:r>
            <a:r>
              <a:rPr lang="en-US" altLang="zh-CN" sz="105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: complementation</a:t>
            </a:r>
            <a:r>
              <a:rPr lang="en-US" altLang="zh-CN" sz="1050" kern="0" dirty="0"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endParaRPr lang="zh-CN" altLang="zh-CN" sz="105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049" name="Rectangle 1"/>
          <p:cNvSpPr>
            <a:spLocks noChangeArrowheads="1"/>
          </p:cNvSpPr>
          <p:nvPr/>
        </p:nvSpPr>
        <p:spPr bwMode="auto">
          <a:xfrm>
            <a:off x="533400" y="1036320"/>
            <a:ext cx="519684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rgbClr val="C00000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Degenerate primers for cloning </a:t>
            </a:r>
            <a:r>
              <a:rPr kumimoji="0" lang="en-US" altLang="zh-CN" sz="1200" b="0" i="1" u="none" strike="noStrike" cap="none" normalizeH="0" baseline="0" dirty="0" smtClean="0">
                <a:ln>
                  <a:noFill/>
                </a:ln>
                <a:solidFill>
                  <a:srgbClr val="C00000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HtNHX1/2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rgbClr val="C00000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 fragment </a:t>
            </a:r>
            <a:endParaRPr kumimoji="0" lang="en-US" altLang="zh-CN" sz="2800" b="0" i="0" u="none" strike="noStrike" cap="none" normalizeH="0" baseline="0" dirty="0" smtClean="0">
              <a:ln>
                <a:noFill/>
              </a:ln>
              <a:solidFill>
                <a:srgbClr val="C00000"/>
              </a:solidFill>
              <a:effectLst/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graphicFrame>
        <p:nvGraphicFramePr>
          <p:cNvPr id="17" name="表格 1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390441598"/>
              </p:ext>
            </p:extLst>
          </p:nvPr>
        </p:nvGraphicFramePr>
        <p:xfrm>
          <a:off x="656272" y="1415718"/>
          <a:ext cx="5368608" cy="1894527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014314"/>
                <a:gridCol w="4354294"/>
              </a:tblGrid>
              <a:tr h="174442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100" dirty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 name</a:t>
                      </a:r>
                      <a:endParaRPr lang="zh-CN" sz="1050" kern="100" dirty="0">
                        <a:solidFill>
                          <a:srgbClr val="C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100" dirty="0" smtClean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 (5</a:t>
                      </a:r>
                      <a:r>
                        <a:rPr lang="en-US" sz="1050" kern="100" dirty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' to </a:t>
                      </a:r>
                      <a:r>
                        <a:rPr lang="en-US" sz="1050" kern="100" dirty="0" smtClean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’)</a:t>
                      </a:r>
                      <a:endParaRPr lang="zh-CN" sz="1050" kern="100" dirty="0">
                        <a:solidFill>
                          <a:srgbClr val="C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</a:tr>
              <a:tr h="166135">
                <a:tc>
                  <a:txBody>
                    <a:bodyPr/>
                    <a:lstStyle/>
                    <a:p>
                      <a:pPr marL="0" algn="l" defTabSz="685800" rtl="0" eaLnBrk="1" latinLnBrk="0" hangingPunct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b="1" kern="0" dirty="0" smtClean="0">
                          <a:solidFill>
                            <a:srgbClr val="C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1:</a:t>
                      </a:r>
                      <a:endParaRPr lang="zh-CN" sz="1050" b="1" kern="0" dirty="0">
                        <a:solidFill>
                          <a:srgbClr val="C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 dirty="0" smtClean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’</a:t>
                      </a:r>
                      <a:r>
                        <a:rPr lang="en-US" altLang="zh-CN" sz="1050" kern="0" dirty="0" smtClean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CCCATTA(C,T)AC</a:t>
                      </a:r>
                      <a:r>
                        <a:rPr lang="en-US" sz="1050" kern="0" dirty="0" smtClean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A,T,C)TGGCACAATGT3</a:t>
                      </a:r>
                      <a:r>
                        <a:rPr lang="zh-CN" altLang="en-US" sz="1050" kern="0" dirty="0" smtClean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’</a:t>
                      </a:r>
                      <a:endParaRPr lang="zh-CN" sz="1050" kern="0" dirty="0">
                        <a:solidFill>
                          <a:srgbClr val="C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</a:tr>
              <a:tr h="166135">
                <a:tc>
                  <a:txBody>
                    <a:bodyPr/>
                    <a:lstStyle/>
                    <a:p>
                      <a:pPr marL="0" algn="l" defTabSz="685800" rtl="0" eaLnBrk="1" latinLnBrk="0" hangingPunct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b="1" kern="0" dirty="0" smtClean="0">
                          <a:solidFill>
                            <a:srgbClr val="C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2:</a:t>
                      </a:r>
                      <a:endParaRPr lang="zh-CN" sz="1050" b="1" kern="0" dirty="0">
                        <a:solidFill>
                          <a:srgbClr val="C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 dirty="0" smtClean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’</a:t>
                      </a:r>
                      <a:r>
                        <a:rPr lang="en-US" altLang="zh-CN" sz="1050" kern="0" dirty="0" smtClean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TTAT</a:t>
                      </a:r>
                      <a:r>
                        <a:rPr lang="en-US" sz="1050" kern="0" dirty="0" smtClean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A,C,G)GT(A,</a:t>
                      </a:r>
                      <a:r>
                        <a:rPr lang="en-US" altLang="zh-CN" sz="1050" kern="0" dirty="0" smtClean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</a:t>
                      </a:r>
                      <a:r>
                        <a:rPr lang="en-US" sz="1050" kern="0" dirty="0" smtClean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)CT(T,C)GTGATCAT3’</a:t>
                      </a:r>
                      <a:endParaRPr lang="zh-CN" sz="1050" kern="0" dirty="0">
                        <a:solidFill>
                          <a:srgbClr val="C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</a:tr>
              <a:tr h="166135">
                <a:tc>
                  <a:txBody>
                    <a:bodyPr/>
                    <a:lstStyle/>
                    <a:p>
                      <a:pPr marL="0" algn="l" defTabSz="685800" rtl="0" eaLnBrk="1" latinLnBrk="0" hangingPunct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b="1" kern="0" dirty="0" smtClean="0">
                          <a:solidFill>
                            <a:srgbClr val="C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3:</a:t>
                      </a:r>
                      <a:endParaRPr lang="zh-CN" sz="1050" b="1" kern="0" dirty="0">
                        <a:solidFill>
                          <a:srgbClr val="C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 dirty="0" smtClean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’TCCAGAGTAACAACCAAGCACGCC3’ (for 5’ RACE PCR)</a:t>
                      </a:r>
                      <a:endParaRPr lang="zh-CN" sz="1050" kern="0" dirty="0">
                        <a:solidFill>
                          <a:srgbClr val="C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</a:tr>
              <a:tr h="166135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 dirty="0" smtClean="0">
                          <a:solidFill>
                            <a:srgbClr val="C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P4:</a:t>
                      </a:r>
                      <a:endParaRPr lang="zh-CN" sz="1050" kern="100" dirty="0">
                        <a:solidFill>
                          <a:srgbClr val="C00000"/>
                        </a:solidFill>
                        <a:effectLst/>
                        <a:latin typeface="Arial" pitchFamily="34" charset="0"/>
                        <a:ea typeface="宋体" panose="02010600030101010101" pitchFamily="2" charset="-122"/>
                        <a:cs typeface="Arial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 dirty="0" smtClean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’TGGCACAATGTCACCGAGAAATC3’ (for 5’ nested RACE PCR)</a:t>
                      </a:r>
                      <a:endParaRPr lang="zh-CN" sz="1050" kern="0" dirty="0">
                        <a:solidFill>
                          <a:srgbClr val="C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</a:tr>
              <a:tr h="166135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 dirty="0" smtClean="0">
                          <a:solidFill>
                            <a:srgbClr val="C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P5:</a:t>
                      </a:r>
                      <a:endParaRPr lang="zh-CN" sz="1050" kern="100" dirty="0">
                        <a:solidFill>
                          <a:srgbClr val="C00000"/>
                        </a:solidFill>
                        <a:effectLst/>
                        <a:latin typeface="Arial" pitchFamily="34" charset="0"/>
                        <a:ea typeface="宋体" panose="02010600030101010101" pitchFamily="2" charset="-122"/>
                        <a:cs typeface="Arial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 dirty="0" smtClean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’GCATTCCCAGGCATTGTTGTGTGA3’ (for 3’ RACE PCR)</a:t>
                      </a:r>
                      <a:endParaRPr lang="zh-CN" sz="1050" kern="0" dirty="0">
                        <a:solidFill>
                          <a:srgbClr val="C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</a:tr>
              <a:tr h="166135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1050" kern="100" dirty="0" smtClean="0">
                          <a:solidFill>
                            <a:srgbClr val="C00000"/>
                          </a:solidFill>
                          <a:effectLst/>
                          <a:latin typeface="Arial" pitchFamily="34" charset="0"/>
                          <a:ea typeface="宋体" panose="02010600030101010101" pitchFamily="2" charset="-122"/>
                          <a:cs typeface="Arial" pitchFamily="34" charset="0"/>
                        </a:rPr>
                        <a:t>P6:</a:t>
                      </a:r>
                      <a:endParaRPr lang="zh-CN" sz="1050" kern="100" dirty="0">
                        <a:solidFill>
                          <a:srgbClr val="C00000"/>
                        </a:solidFill>
                        <a:effectLst/>
                        <a:latin typeface="Arial" pitchFamily="34" charset="0"/>
                        <a:ea typeface="宋体" panose="02010600030101010101" pitchFamily="2" charset="-122"/>
                        <a:cs typeface="Arial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 dirty="0" smtClean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’ CCAAAAAGGCCCAACACGAGAAGA 3’ (for 3’ nested RACE PCR)</a:t>
                      </a:r>
                      <a:endParaRPr lang="zh-CN" sz="1050" kern="0" dirty="0">
                        <a:solidFill>
                          <a:srgbClr val="C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</a:tr>
              <a:tr h="166135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 dirty="0" smtClean="0">
                          <a:solidFill>
                            <a:srgbClr val="C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P7:</a:t>
                      </a:r>
                      <a:endParaRPr lang="zh-CN" sz="1050" kern="100" dirty="0">
                        <a:solidFill>
                          <a:srgbClr val="C00000"/>
                        </a:solidFill>
                        <a:effectLst/>
                        <a:latin typeface="Arial" pitchFamily="34" charset="0"/>
                        <a:ea typeface="宋体" panose="02010600030101010101" pitchFamily="2" charset="-122"/>
                        <a:cs typeface="Arial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 dirty="0" smtClean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’CCCCCCAAGATTCAATTTTTAGAT3’</a:t>
                      </a:r>
                      <a:endParaRPr lang="zh-CN" sz="1050" kern="0" dirty="0">
                        <a:solidFill>
                          <a:srgbClr val="C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 dirty="0" smtClean="0">
                          <a:solidFill>
                            <a:srgbClr val="C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P8:</a:t>
                      </a:r>
                      <a:endParaRPr lang="zh-CN" sz="1050" kern="100" dirty="0">
                        <a:solidFill>
                          <a:srgbClr val="C00000"/>
                        </a:solidFill>
                        <a:effectLst/>
                        <a:latin typeface="Arial" pitchFamily="34" charset="0"/>
                        <a:ea typeface="宋体" panose="02010600030101010101" pitchFamily="2" charset="-122"/>
                        <a:cs typeface="Arial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 dirty="0" smtClean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’- GCACCTTAAAACCAAAACTCAACAC -3’</a:t>
                      </a:r>
                      <a:endParaRPr lang="zh-CN" sz="1050" kern="0" dirty="0">
                        <a:solidFill>
                          <a:srgbClr val="C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xmlns="" val="8207128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15697" y="4523231"/>
            <a:ext cx="5596128" cy="341377"/>
          </a:xfrm>
        </p:spPr>
        <p:txBody>
          <a:bodyPr>
            <a:norm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2. The properties of the soil used in the experiments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表格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780366148"/>
              </p:ext>
            </p:extLst>
          </p:nvPr>
        </p:nvGraphicFramePr>
        <p:xfrm>
          <a:off x="634034" y="4896157"/>
          <a:ext cx="5548320" cy="287845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24720">
                  <a:extLst>
                    <a:ext uri="{9D8B030D-6E8A-4147-A177-3AD203B41FA5}">
                      <a16:colId xmlns="" xmlns:a16="http://schemas.microsoft.com/office/drawing/2014/main" val="868757116"/>
                    </a:ext>
                  </a:extLst>
                </a:gridCol>
                <a:gridCol w="924720">
                  <a:extLst>
                    <a:ext uri="{9D8B030D-6E8A-4147-A177-3AD203B41FA5}">
                      <a16:colId xmlns="" xmlns:a16="http://schemas.microsoft.com/office/drawing/2014/main" val="2567816107"/>
                    </a:ext>
                  </a:extLst>
                </a:gridCol>
                <a:gridCol w="924720">
                  <a:extLst>
                    <a:ext uri="{9D8B030D-6E8A-4147-A177-3AD203B41FA5}">
                      <a16:colId xmlns="" xmlns:a16="http://schemas.microsoft.com/office/drawing/2014/main" val="4045544136"/>
                    </a:ext>
                  </a:extLst>
                </a:gridCol>
                <a:gridCol w="924720">
                  <a:extLst>
                    <a:ext uri="{9D8B030D-6E8A-4147-A177-3AD203B41FA5}">
                      <a16:colId xmlns="" xmlns:a16="http://schemas.microsoft.com/office/drawing/2014/main" val="1720618051"/>
                    </a:ext>
                  </a:extLst>
                </a:gridCol>
                <a:gridCol w="924720">
                  <a:extLst>
                    <a:ext uri="{9D8B030D-6E8A-4147-A177-3AD203B41FA5}">
                      <a16:colId xmlns="" xmlns:a16="http://schemas.microsoft.com/office/drawing/2014/main" val="2973640308"/>
                    </a:ext>
                  </a:extLst>
                </a:gridCol>
                <a:gridCol w="924720">
                  <a:extLst>
                    <a:ext uri="{9D8B030D-6E8A-4147-A177-3AD203B41FA5}">
                      <a16:colId xmlns="" xmlns:a16="http://schemas.microsoft.com/office/drawing/2014/main" val="292654023"/>
                    </a:ext>
                  </a:extLst>
                </a:gridCol>
              </a:tblGrid>
              <a:tr h="71818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il</a:t>
                      </a:r>
                      <a:endParaRPr lang="zh-CN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ganic</a:t>
                      </a:r>
                      <a:r>
                        <a:rPr lang="en-US" altLang="zh-CN" sz="105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atter (g/kg)</a:t>
                      </a:r>
                      <a:endParaRPr lang="zh-CN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N</a:t>
                      </a:r>
                    </a:p>
                    <a:p>
                      <a:pPr algn="ctr"/>
                      <a:r>
                        <a:rPr lang="en-US" altLang="zh-CN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g/kg)</a:t>
                      </a:r>
                      <a:endParaRPr lang="zh-CN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zh-CN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vailable N</a:t>
                      </a:r>
                    </a:p>
                    <a:p>
                      <a:pPr algn="ctr"/>
                      <a:r>
                        <a:rPr lang="en-US" altLang="zh-CN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mg/kg)</a:t>
                      </a:r>
                      <a:endParaRPr lang="zh-CN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vailable</a:t>
                      </a:r>
                      <a:r>
                        <a:rPr lang="en-US" altLang="zh-CN" sz="105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(mg/kg)</a:t>
                      </a:r>
                      <a:endParaRPr lang="zh-CN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vailable</a:t>
                      </a:r>
                      <a:r>
                        <a:rPr lang="en-US" altLang="zh-CN" sz="105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K (mg/kg)</a:t>
                      </a:r>
                      <a:endParaRPr lang="zh-CN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3777984165"/>
                  </a:ext>
                </a:extLst>
              </a:tr>
              <a:tr h="723900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50" kern="1200" dirty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Fertile soil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50" kern="1200" dirty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for salt stress test)</a:t>
                      </a:r>
                      <a:endParaRPr lang="zh-CN" altLang="en-US" sz="1050" kern="1200" dirty="0">
                        <a:solidFill>
                          <a:schemeClr val="dk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50" kern="1200" dirty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9.7</a:t>
                      </a:r>
                      <a:endParaRPr lang="zh-CN" altLang="en-US" sz="1050" kern="1200" dirty="0">
                        <a:solidFill>
                          <a:schemeClr val="dk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</a:t>
                      </a:r>
                      <a:endParaRPr lang="zh-CN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</a:t>
                      </a:r>
                      <a:endParaRPr lang="zh-CN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</a:t>
                      </a:r>
                      <a:endParaRPr lang="zh-CN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3</a:t>
                      </a:r>
                      <a:endParaRPr lang="zh-CN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2143096800"/>
                  </a:ext>
                </a:extLst>
              </a:tr>
              <a:tr h="71818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 K soil</a:t>
                      </a:r>
                      <a:endParaRPr lang="zh-CN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3</a:t>
                      </a:r>
                      <a:endParaRPr lang="zh-CN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</a:t>
                      </a:r>
                      <a:endParaRPr lang="zh-CN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</a:t>
                      </a:r>
                      <a:endParaRPr lang="zh-CN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  <a:endParaRPr lang="zh-CN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</a:t>
                      </a:r>
                      <a:endParaRPr lang="zh-CN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1945154533"/>
                  </a:ext>
                </a:extLst>
              </a:tr>
              <a:tr h="71818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fertile soil</a:t>
                      </a:r>
                      <a:endParaRPr lang="zh-CN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7</a:t>
                      </a:r>
                      <a:endParaRPr lang="zh-CN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2</a:t>
                      </a:r>
                      <a:endParaRPr lang="zh-CN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</a:t>
                      </a:r>
                      <a:endParaRPr lang="zh-CN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zh-CN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</a:t>
                      </a:r>
                      <a:endParaRPr lang="zh-CN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2784492376"/>
                  </a:ext>
                </a:extLst>
              </a:tr>
            </a:tbl>
          </a:graphicData>
        </a:graphic>
      </p:graphicFrame>
      <p:graphicFrame>
        <p:nvGraphicFramePr>
          <p:cNvPr id="4" name="表格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2922704346"/>
              </p:ext>
            </p:extLst>
          </p:nvPr>
        </p:nvGraphicFramePr>
        <p:xfrm>
          <a:off x="715009" y="1246743"/>
          <a:ext cx="5392737" cy="264033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712361"/>
                <a:gridCol w="2680376"/>
              </a:tblGrid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 name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 (5</a:t>
                      </a:r>
                      <a:r>
                        <a:rPr lang="en-US" sz="105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' to </a:t>
                      </a:r>
                      <a:r>
                        <a:rPr lang="en-US" sz="1050" kern="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’)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</a:tr>
              <a:tr h="209644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mi-</a:t>
                      </a:r>
                      <a:r>
                        <a:rPr lang="en-US" sz="1050" kern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tActin</a:t>
                      </a:r>
                      <a:r>
                        <a:rPr lang="en-US" sz="105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F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ACGGAGACAATAACACTGG 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</a:tr>
              <a:tr h="209644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mi-HtActin-R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GTGAAGCAGTGGTGATGAAC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</a:tr>
              <a:tr h="209644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mi-HtNHX1-F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GAGTGGCATTCTCACAG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</a:tr>
              <a:tr h="209644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mi-HtNHX1-R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GGACGGTGTGACTTGG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</a:tr>
              <a:tr h="209644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mi-HtNHX2-F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GACCATTGTTCTATTCGG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</a:tr>
              <a:tr h="209644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mi-HtNHX2-R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CCACCATATTAAAACCTC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</a:tr>
              <a:tr h="209644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HtActin-F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GTATGTAGCCATCCAGG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</a:tr>
              <a:tr h="209644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HtActin-R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TTAGGTCACGCCCAG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</a:tr>
              <a:tr h="209644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HtNHX1-F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GAGTAACAACCAAGCACGC</a:t>
                      </a:r>
                      <a:endParaRPr lang="zh-CN" sz="105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</a:tr>
              <a:tr h="209644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HtNHX1-R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TGCTCTTCCAACCAATACC</a:t>
                      </a:r>
                      <a:endParaRPr lang="zh-CN" sz="105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</a:tr>
            </a:tbl>
          </a:graphicData>
        </a:graphic>
      </p:graphicFrame>
      <p:sp>
        <p:nvSpPr>
          <p:cNvPr id="5" name="矩形 4"/>
          <p:cNvSpPr/>
          <p:nvPr/>
        </p:nvSpPr>
        <p:spPr>
          <a:xfrm>
            <a:off x="688848" y="722772"/>
            <a:ext cx="534035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he primers for </a:t>
            </a:r>
            <a:r>
              <a:rPr lang="en-US" altLang="zh-CN" sz="1200" dirty="0" smtClean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emi-quantitative </a:t>
            </a:r>
            <a:r>
              <a:rPr lang="en-US" altLang="zh-CN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T-PCR and </a:t>
            </a:r>
            <a:r>
              <a:rPr lang="en-US" altLang="zh-CN" sz="1200" dirty="0" smtClean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eal-time </a:t>
            </a:r>
            <a:r>
              <a:rPr lang="en-US" altLang="zh-CN" sz="1200" dirty="0" err="1" smtClean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qRT</a:t>
            </a:r>
            <a:r>
              <a:rPr lang="en-US" altLang="zh-CN" sz="1200" dirty="0" smtClean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-PCR </a:t>
            </a:r>
            <a:r>
              <a:rPr lang="en-US" altLang="zh-CN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of </a:t>
            </a:r>
            <a:r>
              <a:rPr lang="en-US" altLang="zh-CN" sz="1200" i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HtNHX1/2</a:t>
            </a:r>
            <a:endParaRPr lang="zh-CN" altLang="zh-CN" sz="1200" i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40337153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938</TotalTime>
  <Words>868</Words>
  <Application>Microsoft Office PowerPoint</Application>
  <PresentationFormat>全屏显示(4:3)</PresentationFormat>
  <Paragraphs>170</Paragraphs>
  <Slides>8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9" baseType="lpstr">
      <vt:lpstr>Office 主题​​</vt:lpstr>
      <vt:lpstr>幻灯片 1</vt:lpstr>
      <vt:lpstr>幻灯片 2</vt:lpstr>
      <vt:lpstr>幻灯片 3</vt:lpstr>
      <vt:lpstr>幻灯片 4</vt:lpstr>
      <vt:lpstr>幻灯片 5</vt:lpstr>
      <vt:lpstr>幻灯片 6</vt:lpstr>
      <vt:lpstr>Supplemental Table 1. The primers used in the experiments</vt:lpstr>
      <vt:lpstr>Supplemental Table 2. The properties of the soil used in the experiments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uguohua</dc:creator>
  <cp:lastModifiedBy>XuGuohua</cp:lastModifiedBy>
  <cp:revision>563</cp:revision>
  <cp:lastPrinted>2017-01-03T03:49:22Z</cp:lastPrinted>
  <dcterms:created xsi:type="dcterms:W3CDTF">2016-11-05T12:14:32Z</dcterms:created>
  <dcterms:modified xsi:type="dcterms:W3CDTF">2017-05-29T15:41:14Z</dcterms:modified>
</cp:coreProperties>
</file>